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BD0DB-59C5-4954-88FA-902936B65D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3A1A2-D44A-4D42-B8AA-318C39D02E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26566-2635-4323-9FC0-58B6681A40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B127B-4402-4064-9C4B-85D7745123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10180-A387-4555-8C39-2E125EFC32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8485B-1314-4417-B3D5-069077A4C9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F98737-FF38-4017-A7B2-EFA187DAE2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6C631-8E86-471A-8A85-C820458290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7A42E-7B2E-4EE4-92F0-66FC7C3993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77487-49E0-459F-8212-DB39DBDC31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1E83C4-5787-435C-9556-9C95B6AEE0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D077D-ED3B-4A24-8189-DD02C94812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6482A5-B18C-40EB-9EF0-8327A0719DE2}" type="slidenum">
              <a:rPr b="0" lang="es-MX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3.wmf"/><Relationship Id="rId5" Type="http://schemas.openxmlformats.org/officeDocument/2006/relationships/image" Target="../media/image4.wmf"/><Relationship Id="rId6" Type="http://schemas.openxmlformats.org/officeDocument/2006/relationships/image" Target="../media/image5.wmf"/><Relationship Id="rId7" Type="http://schemas.openxmlformats.org/officeDocument/2006/relationships/image" Target="../media/image6.wmf"/><Relationship Id="rId8" Type="http://schemas.openxmlformats.org/officeDocument/2006/relationships/image" Target="../media/image7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7"/>
          <p:cNvSpPr/>
          <p:nvPr/>
        </p:nvSpPr>
        <p:spPr>
          <a:xfrm>
            <a:off x="333360" y="6467400"/>
            <a:ext cx="6227640" cy="121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 | Colonization dynamics of 3D BM spheroids by normal and leukemic cell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3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normal and leukemic cells were uniformly labeled with blue and red fluorescent dyes, respectively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FI determinations of blue, red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green (CXCL12)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fluorescent channels on 3D spheroids are shown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MPB-CD34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2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-CD34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2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-M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3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-M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4). MSC: Mesenchymal Stromal Cells; NBM: Normal Bone Marrow; ALL: Acute Lymphoblastic Leukemia; Mononuclear Cells (MNC); MFI: Mean Fluorescence Intensity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48 Grupo"/>
          <p:cNvGrpSpPr/>
          <p:nvPr/>
        </p:nvGrpSpPr>
        <p:grpSpPr>
          <a:xfrm>
            <a:off x="910800" y="971640"/>
            <a:ext cx="5503320" cy="5292720"/>
            <a:chOff x="910800" y="971640"/>
            <a:chExt cx="5503320" cy="5292720"/>
          </a:xfrm>
        </p:grpSpPr>
        <p:grpSp>
          <p:nvGrpSpPr>
            <p:cNvPr id="43" name="Group 11"/>
            <p:cNvGrpSpPr/>
            <p:nvPr/>
          </p:nvGrpSpPr>
          <p:grpSpPr>
            <a:xfrm>
              <a:off x="1073160" y="3566160"/>
              <a:ext cx="2230200" cy="1197000"/>
              <a:chOff x="1073160" y="3566160"/>
              <a:chExt cx="2230200" cy="1197000"/>
            </a:xfrm>
          </p:grpSpPr>
          <p:sp>
            <p:nvSpPr>
              <p:cNvPr id="44" name="CuadroTexto 15"/>
              <p:cNvSpPr/>
              <p:nvPr/>
            </p:nvSpPr>
            <p:spPr>
              <a:xfrm>
                <a:off x="1557000" y="4427640"/>
                <a:ext cx="59040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24 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CuadroTexto 15"/>
              <p:cNvSpPr/>
              <p:nvPr/>
            </p:nvSpPr>
            <p:spPr>
              <a:xfrm>
                <a:off x="2712960" y="4427640"/>
                <a:ext cx="59040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24 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CuadroTexto 15"/>
              <p:cNvSpPr/>
              <p:nvPr/>
            </p:nvSpPr>
            <p:spPr>
              <a:xfrm rot="16200000">
                <a:off x="944640" y="3694320"/>
                <a:ext cx="59220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MF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7" name="CuadroTexto 15"/>
            <p:cNvSpPr/>
            <p:nvPr/>
          </p:nvSpPr>
          <p:spPr>
            <a:xfrm>
              <a:off x="4040640" y="4444920"/>
              <a:ext cx="590400" cy="33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Times New Roman"/>
                </a:rPr>
                <a:t>24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CuadroTexto 15"/>
            <p:cNvSpPr/>
            <p:nvPr/>
          </p:nvSpPr>
          <p:spPr>
            <a:xfrm>
              <a:off x="4716720" y="4449600"/>
              <a:ext cx="654480" cy="33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Times New Roman"/>
                </a:rPr>
                <a:t>120 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9" name="45 Grupo"/>
            <p:cNvGrpSpPr/>
            <p:nvPr/>
          </p:nvGrpSpPr>
          <p:grpSpPr>
            <a:xfrm>
              <a:off x="1974600" y="1115640"/>
              <a:ext cx="2741400" cy="1851120"/>
              <a:chOff x="1974600" y="1115640"/>
              <a:chExt cx="2741400" cy="1851120"/>
            </a:xfrm>
          </p:grpSpPr>
          <p:grpSp>
            <p:nvGrpSpPr>
              <p:cNvPr id="50" name="Group 10"/>
              <p:cNvGrpSpPr/>
              <p:nvPr/>
            </p:nvGrpSpPr>
            <p:grpSpPr>
              <a:xfrm>
                <a:off x="1974600" y="1298160"/>
                <a:ext cx="2741400" cy="1668600"/>
                <a:chOff x="1974600" y="1298160"/>
                <a:chExt cx="2741400" cy="1668600"/>
              </a:xfrm>
            </p:grpSpPr>
            <p:sp>
              <p:nvSpPr>
                <p:cNvPr id="51" name="CuadroTexto 15"/>
                <p:cNvSpPr/>
                <p:nvPr/>
              </p:nvSpPr>
              <p:spPr>
                <a:xfrm>
                  <a:off x="2011320" y="2625120"/>
                  <a:ext cx="1247400" cy="335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182880" rIns="182880" tIns="91440" b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000" spc="-1" strike="noStrike">
                      <a:solidFill>
                        <a:srgbClr val="000000"/>
                      </a:solidFill>
                      <a:latin typeface="Times New Roman"/>
                    </a:rPr>
                    <a:t>Cell Trace Violet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52" name="Conector recto de flecha 13"/>
                <p:cNvCxnSpPr/>
                <p:nvPr/>
              </p:nvCxnSpPr>
              <p:spPr>
                <a:xfrm>
                  <a:off x="3436560" y="2657160"/>
                  <a:ext cx="1146960" cy="108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53" name="CuadroTexto 15"/>
                <p:cNvSpPr/>
                <p:nvPr/>
              </p:nvSpPr>
              <p:spPr>
                <a:xfrm>
                  <a:off x="3380400" y="2631240"/>
                  <a:ext cx="1335600" cy="335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182880" rIns="182880" tIns="91440" b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000" spc="-1" strike="noStrike">
                      <a:solidFill>
                        <a:srgbClr val="000000"/>
                      </a:solidFill>
                      <a:latin typeface="Times New Roman"/>
                    </a:rPr>
                    <a:t>Cell Trace Far Red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54" name="Conector recto de flecha 13"/>
                <p:cNvCxnSpPr/>
                <p:nvPr/>
              </p:nvCxnSpPr>
              <p:spPr>
                <a:xfrm>
                  <a:off x="2067840" y="2657160"/>
                  <a:ext cx="1146960" cy="1080"/>
                </a:xfrm>
                <a:prstGeom prst="straightConnector1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pic>
              <p:nvPicPr>
                <p:cNvPr id="55" name="Picture 1" descr=""/>
                <p:cNvPicPr/>
                <p:nvPr/>
              </p:nvPicPr>
              <p:blipFill>
                <a:blip r:embed="rId1"/>
                <a:srcRect l="13070" t="0" r="0" b="22165"/>
                <a:stretch/>
              </p:blipFill>
              <p:spPr>
                <a:xfrm>
                  <a:off x="1974600" y="1298160"/>
                  <a:ext cx="1250640" cy="1315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6" name="Picture 2" descr=""/>
                <p:cNvPicPr/>
                <p:nvPr/>
              </p:nvPicPr>
              <p:blipFill>
                <a:blip r:embed="rId2"/>
                <a:srcRect l="8313" t="0" r="0" b="18432"/>
                <a:stretch/>
              </p:blipFill>
              <p:spPr>
                <a:xfrm>
                  <a:off x="3264120" y="1308960"/>
                  <a:ext cx="1296360" cy="13150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57" name="CuadroTexto 15"/>
              <p:cNvSpPr/>
              <p:nvPr/>
            </p:nvSpPr>
            <p:spPr>
              <a:xfrm>
                <a:off x="3591000" y="1120320"/>
                <a:ext cx="98964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CD34</a:t>
                </a:r>
                <a:r>
                  <a:rPr b="0" lang="es-ES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+</a:t>
                </a: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 AL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CuadroTexto 15"/>
              <p:cNvSpPr/>
              <p:nvPr/>
            </p:nvSpPr>
            <p:spPr>
              <a:xfrm>
                <a:off x="2207880" y="1115640"/>
                <a:ext cx="100944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CD34</a:t>
                </a:r>
                <a:r>
                  <a:rPr b="0" lang="es-ES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+</a:t>
                </a: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 MP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TextBox 35"/>
            <p:cNvSpPr/>
            <p:nvPr/>
          </p:nvSpPr>
          <p:spPr>
            <a:xfrm>
              <a:off x="1342800" y="971640"/>
              <a:ext cx="57672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36"/>
            <p:cNvSpPr/>
            <p:nvPr/>
          </p:nvSpPr>
          <p:spPr>
            <a:xfrm>
              <a:off x="912600" y="2771640"/>
              <a:ext cx="56916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47 Grupo"/>
            <p:cNvGrpSpPr/>
            <p:nvPr/>
          </p:nvGrpSpPr>
          <p:grpSpPr>
            <a:xfrm>
              <a:off x="910800" y="4643640"/>
              <a:ext cx="3067920" cy="1620720"/>
              <a:chOff x="910800" y="4643640"/>
              <a:chExt cx="3067920" cy="1620720"/>
            </a:xfrm>
          </p:grpSpPr>
          <p:pic>
            <p:nvPicPr>
              <p:cNvPr id="62" name="Picture 38" descr=""/>
              <p:cNvPicPr/>
              <p:nvPr/>
            </p:nvPicPr>
            <p:blipFill>
              <a:blip r:embed="rId3"/>
              <a:srcRect l="3826" t="2848" r="35916" b="22453"/>
              <a:stretch/>
            </p:blipFill>
            <p:spPr>
              <a:xfrm>
                <a:off x="1393200" y="4971960"/>
                <a:ext cx="1565280" cy="10159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63" name="Group 39"/>
              <p:cNvGrpSpPr/>
              <p:nvPr/>
            </p:nvGrpSpPr>
            <p:grpSpPr>
              <a:xfrm>
                <a:off x="1177200" y="5004000"/>
                <a:ext cx="1751760" cy="1260360"/>
                <a:chOff x="1177200" y="5004000"/>
                <a:chExt cx="1751760" cy="1260360"/>
              </a:xfrm>
            </p:grpSpPr>
            <p:sp>
              <p:nvSpPr>
                <p:cNvPr id="64" name="CuadroTexto 15"/>
                <p:cNvSpPr/>
                <p:nvPr/>
              </p:nvSpPr>
              <p:spPr>
                <a:xfrm>
                  <a:off x="1635480" y="5923440"/>
                  <a:ext cx="590400" cy="335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182880" rIns="182880" tIns="91440" b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000" spc="-1" strike="noStrike">
                      <a:solidFill>
                        <a:srgbClr val="000000"/>
                      </a:solidFill>
                      <a:latin typeface="Times New Roman"/>
                    </a:rPr>
                    <a:t>24 h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CuadroTexto 15"/>
                <p:cNvSpPr/>
                <p:nvPr/>
              </p:nvSpPr>
              <p:spPr>
                <a:xfrm>
                  <a:off x="2274480" y="5928840"/>
                  <a:ext cx="654480" cy="335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182880" rIns="182880" tIns="91440" b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000" spc="-1" strike="noStrike">
                      <a:solidFill>
                        <a:srgbClr val="000000"/>
                      </a:solidFill>
                      <a:latin typeface="Times New Roman"/>
                    </a:rPr>
                    <a:t>120 h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CuadroTexto 15"/>
                <p:cNvSpPr/>
                <p:nvPr/>
              </p:nvSpPr>
              <p:spPr>
                <a:xfrm rot="16200000">
                  <a:off x="1048680" y="5337360"/>
                  <a:ext cx="592200" cy="335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182880" rIns="182880" tIns="91440" bIns="9144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000" spc="-1" strike="noStrike">
                      <a:solidFill>
                        <a:srgbClr val="000000"/>
                      </a:solidFill>
                      <a:latin typeface="Times New Roman"/>
                    </a:rPr>
                    <a:t>MFI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CuadroTexto 27"/>
                <p:cNvSpPr/>
                <p:nvPr/>
              </p:nvSpPr>
              <p:spPr>
                <a:xfrm>
                  <a:off x="1826280" y="5004000"/>
                  <a:ext cx="2721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Times New Roman"/>
                    </a:rPr>
                    <a:t>n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8" name="TextBox 47"/>
              <p:cNvSpPr/>
              <p:nvPr/>
            </p:nvSpPr>
            <p:spPr>
              <a:xfrm>
                <a:off x="910800" y="4643640"/>
                <a:ext cx="576720" cy="365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(C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CuadroTexto 27"/>
              <p:cNvSpPr/>
              <p:nvPr/>
            </p:nvSpPr>
            <p:spPr>
              <a:xfrm>
                <a:off x="2374920" y="5091120"/>
                <a:ext cx="534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s-ES" sz="800" spc="-1" strike="noStrike">
                    <a:solidFill>
                      <a:srgbClr val="000000"/>
                    </a:solidFill>
                    <a:latin typeface="Times New Roman"/>
                  </a:rPr>
                  <a:t>p=0.0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CuadroTexto 27"/>
              <p:cNvSpPr/>
              <p:nvPr/>
            </p:nvSpPr>
            <p:spPr>
              <a:xfrm>
                <a:off x="2514240" y="5274360"/>
                <a:ext cx="2325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b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1" name="Picture 38" descr=""/>
              <p:cNvPicPr/>
              <p:nvPr/>
            </p:nvPicPr>
            <p:blipFill>
              <a:blip r:embed="rId4"/>
              <a:srcRect l="66461" t="2848" r="25950" b="79799"/>
              <a:stretch/>
            </p:blipFill>
            <p:spPr>
              <a:xfrm>
                <a:off x="2930040" y="4964040"/>
                <a:ext cx="241200" cy="288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2" name="CuadroTexto 15"/>
              <p:cNvSpPr/>
              <p:nvPr/>
            </p:nvSpPr>
            <p:spPr>
              <a:xfrm>
                <a:off x="3015000" y="4842000"/>
                <a:ext cx="96372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NBM-MS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CuadroTexto 15"/>
              <p:cNvSpPr/>
              <p:nvPr/>
            </p:nvSpPr>
            <p:spPr>
              <a:xfrm>
                <a:off x="3007440" y="4986360"/>
                <a:ext cx="92268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ALL-MS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4" name="46 Grupo"/>
            <p:cNvGrpSpPr/>
            <p:nvPr/>
          </p:nvGrpSpPr>
          <p:grpSpPr>
            <a:xfrm>
              <a:off x="1280520" y="3059640"/>
              <a:ext cx="5133600" cy="1401480"/>
              <a:chOff x="1280520" y="3059640"/>
              <a:chExt cx="5133600" cy="1401480"/>
            </a:xfrm>
          </p:grpSpPr>
          <p:pic>
            <p:nvPicPr>
              <p:cNvPr id="75" name="Picture 2" descr=""/>
              <p:cNvPicPr/>
              <p:nvPr/>
            </p:nvPicPr>
            <p:blipFill>
              <a:blip r:embed="rId5"/>
              <a:srcRect l="4755" t="0" r="60591" b="21341"/>
              <a:stretch/>
            </p:blipFill>
            <p:spPr>
              <a:xfrm>
                <a:off x="2515680" y="3346920"/>
                <a:ext cx="936720" cy="1112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6" name="Picture 1" descr=""/>
              <p:cNvPicPr/>
              <p:nvPr/>
            </p:nvPicPr>
            <p:blipFill>
              <a:blip r:embed="rId6"/>
              <a:srcRect l="4755" t="0" r="60591" b="22241"/>
              <a:stretch/>
            </p:blipFill>
            <p:spPr>
              <a:xfrm>
                <a:off x="1364760" y="3346920"/>
                <a:ext cx="949320" cy="1114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7" name="Picture 9" descr=""/>
              <p:cNvPicPr/>
              <p:nvPr/>
            </p:nvPicPr>
            <p:blipFill>
              <a:blip r:embed="rId7"/>
              <a:srcRect l="5337" t="0" r="35916" b="22321"/>
              <a:stretch/>
            </p:blipFill>
            <p:spPr>
              <a:xfrm>
                <a:off x="3857400" y="3387960"/>
                <a:ext cx="1525680" cy="1055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8" name="CuadroTexto 27"/>
              <p:cNvSpPr/>
              <p:nvPr/>
            </p:nvSpPr>
            <p:spPr>
              <a:xfrm>
                <a:off x="4769640" y="3183840"/>
                <a:ext cx="534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b">
                <a:spAutoFit/>
              </a:bodyPr>
              <a:p>
                <a:pPr>
                  <a:lnSpc>
                    <a:spcPct val="2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s-ES" sz="800" spc="-1" strike="noStrike">
                    <a:solidFill>
                      <a:srgbClr val="000000"/>
                    </a:solidFill>
                    <a:latin typeface="Times New Roman"/>
                  </a:rPr>
                  <a:t>p=0.00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CuadroTexto 27"/>
              <p:cNvSpPr/>
              <p:nvPr/>
            </p:nvSpPr>
            <p:spPr>
              <a:xfrm>
                <a:off x="4895640" y="3328560"/>
                <a:ext cx="284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b">
                <a:spAutoFit/>
              </a:bodyPr>
              <a:p>
                <a:pPr>
                  <a:lnSpc>
                    <a:spcPct val="2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CuadroTexto 15"/>
              <p:cNvSpPr/>
              <p:nvPr/>
            </p:nvSpPr>
            <p:spPr>
              <a:xfrm rot="16200000">
                <a:off x="3473280" y="3790080"/>
                <a:ext cx="59220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MF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1" name="Picture 27" descr=""/>
              <p:cNvPicPr/>
              <p:nvPr/>
            </p:nvPicPr>
            <p:blipFill>
              <a:blip r:embed="rId8"/>
              <a:srcRect l="65643" t="0" r="28043" b="76646"/>
              <a:stretch/>
            </p:blipFill>
            <p:spPr>
              <a:xfrm>
                <a:off x="5383080" y="3275280"/>
                <a:ext cx="185760" cy="36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2" name="CuadroTexto 15"/>
              <p:cNvSpPr/>
              <p:nvPr/>
            </p:nvSpPr>
            <p:spPr>
              <a:xfrm>
                <a:off x="5404680" y="3224520"/>
                <a:ext cx="100944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CD34</a:t>
                </a:r>
                <a:r>
                  <a:rPr b="0" lang="es-ES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+</a:t>
                </a: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 MP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CuadroTexto 15"/>
              <p:cNvSpPr/>
              <p:nvPr/>
            </p:nvSpPr>
            <p:spPr>
              <a:xfrm>
                <a:off x="5407200" y="3346920"/>
                <a:ext cx="98964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CD34</a:t>
                </a:r>
                <a:r>
                  <a:rPr b="0" lang="es-ES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+</a:t>
                </a: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 AL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CuadroTexto 15"/>
              <p:cNvSpPr/>
              <p:nvPr/>
            </p:nvSpPr>
            <p:spPr>
              <a:xfrm>
                <a:off x="4119480" y="3059640"/>
                <a:ext cx="109944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ALL MSC 3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CuadroTexto 15"/>
              <p:cNvSpPr/>
              <p:nvPr/>
            </p:nvSpPr>
            <p:spPr>
              <a:xfrm>
                <a:off x="1280520" y="3062520"/>
                <a:ext cx="115128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NBM-MSC 3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CuadroTexto 15"/>
              <p:cNvSpPr/>
              <p:nvPr/>
            </p:nvSpPr>
            <p:spPr>
              <a:xfrm>
                <a:off x="2481120" y="3062520"/>
                <a:ext cx="111024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ALL-MSC 3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CuadroTexto 15"/>
              <p:cNvSpPr/>
              <p:nvPr/>
            </p:nvSpPr>
            <p:spPr>
              <a:xfrm rot="16200000">
                <a:off x="2171160" y="3745080"/>
                <a:ext cx="59220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MF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CuadroTexto 15"/>
              <p:cNvSpPr/>
              <p:nvPr/>
            </p:nvSpPr>
            <p:spPr>
              <a:xfrm>
                <a:off x="4100400" y="3562560"/>
                <a:ext cx="554040" cy="274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182880" rIns="182880" tIns="91440" bIns="91440" anchor="ctr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2T03:08:14Z</dcterms:created>
  <dc:creator>PELAYO</dc:creator>
  <dc:description/>
  <dc:language>en-US</dc:language>
  <cp:lastModifiedBy>Juan Carlos Balandrán</cp:lastModifiedBy>
  <dcterms:modified xsi:type="dcterms:W3CDTF">2016-12-25T02:41:54Z</dcterms:modified>
  <cp:revision>16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5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StageName">
    <vt:lpwstr>Author's Proof</vt:lpwstr>
  </property>
  <property fmtid="{D5CDD505-2E9C-101B-9397-08002B2CF9AE}" pid="6" name="TitleName">
    <vt:lpwstr>Presentation 5.ppt</vt:lpwstr>
  </property>
</Properties>
</file>